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02" r:id="rId5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CC9900"/>
    <a:srgbClr val="FFCC00"/>
    <a:srgbClr val="FFFFFF"/>
    <a:srgbClr val="E8B7B7"/>
    <a:srgbClr val="A8CDD7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61" autoAdjust="0"/>
  </p:normalViewPr>
  <p:slideViewPr>
    <p:cSldViewPr snapToGrid="0">
      <p:cViewPr varScale="1">
        <p:scale>
          <a:sx n="71" d="100"/>
          <a:sy n="71" d="100"/>
        </p:scale>
        <p:origin x="14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Weis" userId="6a51f4e6-0e93-4a18-834c-a49e1ed77407" providerId="ADAL" clId="{9C5BD01B-F20E-41A2-9B79-9146F06FE46D}"/>
    <pc:docChg chg="custSel addSld delSld modSld">
      <pc:chgData name="Sara Weis" userId="6a51f4e6-0e93-4a18-834c-a49e1ed77407" providerId="ADAL" clId="{9C5BD01B-F20E-41A2-9B79-9146F06FE46D}" dt="2025-01-02T17:22:34.922" v="288" actId="2696"/>
      <pc:docMkLst>
        <pc:docMk/>
      </pc:docMkLst>
      <pc:sldChg chg="del">
        <pc:chgData name="Sara Weis" userId="6a51f4e6-0e93-4a18-834c-a49e1ed77407" providerId="ADAL" clId="{9C5BD01B-F20E-41A2-9B79-9146F06FE46D}" dt="2025-01-02T16:47:45.036" v="0" actId="2696"/>
        <pc:sldMkLst>
          <pc:docMk/>
          <pc:sldMk cId="2106248321" sldId="298"/>
        </pc:sldMkLst>
      </pc:sldChg>
      <pc:sldChg chg="addSp delSp modSp del">
        <pc:chgData name="Sara Weis" userId="6a51f4e6-0e93-4a18-834c-a49e1ed77407" providerId="ADAL" clId="{9C5BD01B-F20E-41A2-9B79-9146F06FE46D}" dt="2025-01-02T17:22:34.922" v="288" actId="2696"/>
        <pc:sldMkLst>
          <pc:docMk/>
          <pc:sldMk cId="3697787146" sldId="301"/>
        </pc:sldMkLst>
        <pc:spChg chg="add mod">
          <ac:chgData name="Sara Weis" userId="6a51f4e6-0e93-4a18-834c-a49e1ed77407" providerId="ADAL" clId="{9C5BD01B-F20E-41A2-9B79-9146F06FE46D}" dt="2025-01-02T17:14:57.246" v="287" actId="20577"/>
          <ac:spMkLst>
            <pc:docMk/>
            <pc:sldMk cId="3697787146" sldId="301"/>
            <ac:spMk id="3" creationId="{5BA8A5DB-8B56-4375-B76B-1DD6A0A66638}"/>
          </ac:spMkLst>
        </pc:spChg>
        <pc:spChg chg="del">
          <ac:chgData name="Sara Weis" userId="6a51f4e6-0e93-4a18-834c-a49e1ed77407" providerId="ADAL" clId="{9C5BD01B-F20E-41A2-9B79-9146F06FE46D}" dt="2025-01-02T17:06:44.709" v="79" actId="478"/>
          <ac:spMkLst>
            <pc:docMk/>
            <pc:sldMk cId="3697787146" sldId="301"/>
            <ac:spMk id="5" creationId="{482EC21A-9C48-44AA-B0BF-C90E2EF40A89}"/>
          </ac:spMkLst>
        </pc:spChg>
        <pc:spChg chg="mod topLvl">
          <ac:chgData name="Sara Weis" userId="6a51f4e6-0e93-4a18-834c-a49e1ed77407" providerId="ADAL" clId="{9C5BD01B-F20E-41A2-9B79-9146F06FE46D}" dt="2025-01-02T17:12:04.497" v="250" actId="1076"/>
          <ac:spMkLst>
            <pc:docMk/>
            <pc:sldMk cId="3697787146" sldId="301"/>
            <ac:spMk id="40" creationId="{17A2B086-922E-4A22-B93C-C1506C9A891D}"/>
          </ac:spMkLst>
        </pc:spChg>
        <pc:spChg chg="mod topLvl">
          <ac:chgData name="Sara Weis" userId="6a51f4e6-0e93-4a18-834c-a49e1ed77407" providerId="ADAL" clId="{9C5BD01B-F20E-41A2-9B79-9146F06FE46D}" dt="2025-01-02T17:12:04.497" v="250" actId="1076"/>
          <ac:spMkLst>
            <pc:docMk/>
            <pc:sldMk cId="3697787146" sldId="301"/>
            <ac:spMk id="43" creationId="{1B63261F-5B34-4FAF-973A-117486502732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6" creationId="{5A252B7C-F590-4C54-827F-9FBE6CA430D2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7" creationId="{315EE578-6B8E-4185-AFF9-650CA9E307E7}"/>
          </ac:spMkLst>
        </pc:spChg>
        <pc:spChg chg="mod">
          <ac:chgData name="Sara Weis" userId="6a51f4e6-0e93-4a18-834c-a49e1ed77407" providerId="ADAL" clId="{9C5BD01B-F20E-41A2-9B79-9146F06FE46D}" dt="2025-01-02T16:53:55.493" v="51" actId="121"/>
          <ac:spMkLst>
            <pc:docMk/>
            <pc:sldMk cId="3697787146" sldId="301"/>
            <ac:spMk id="58" creationId="{22FA14AD-0F20-43B0-9C05-405C97092C1B}"/>
          </ac:spMkLst>
        </pc:spChg>
        <pc:spChg chg="del mod">
          <ac:chgData name="Sara Weis" userId="6a51f4e6-0e93-4a18-834c-a49e1ed77407" providerId="ADAL" clId="{9C5BD01B-F20E-41A2-9B79-9146F06FE46D}" dt="2025-01-02T17:09:54.861" v="85" actId="478"/>
          <ac:spMkLst>
            <pc:docMk/>
            <pc:sldMk cId="3697787146" sldId="301"/>
            <ac:spMk id="61" creationId="{CF3FD69B-8EB1-432C-96B4-539FD5CDF51C}"/>
          </ac:spMkLst>
        </pc:spChg>
        <pc:spChg chg="del mod">
          <ac:chgData name="Sara Weis" userId="6a51f4e6-0e93-4a18-834c-a49e1ed77407" providerId="ADAL" clId="{9C5BD01B-F20E-41A2-9B79-9146F06FE46D}" dt="2025-01-02T17:09:57.133" v="86" actId="478"/>
          <ac:spMkLst>
            <pc:docMk/>
            <pc:sldMk cId="3697787146" sldId="301"/>
            <ac:spMk id="96" creationId="{ED1F1807-7D76-42D5-A6C8-63B4164465BD}"/>
          </ac:spMkLst>
        </pc:spChg>
        <pc:grpChg chg="del mod">
          <ac:chgData name="Sara Weis" userId="6a51f4e6-0e93-4a18-834c-a49e1ed77407" providerId="ADAL" clId="{9C5BD01B-F20E-41A2-9B79-9146F06FE46D}" dt="2025-01-02T17:09:57.133" v="86" actId="478"/>
          <ac:grpSpMkLst>
            <pc:docMk/>
            <pc:sldMk cId="3697787146" sldId="301"/>
            <ac:grpSpMk id="2" creationId="{B3A65566-F496-49EC-9796-C4772607E706}"/>
          </ac:grpSpMkLst>
        </pc:grpChg>
        <pc:grpChg chg="add del mod">
          <ac:chgData name="Sara Weis" userId="6a51f4e6-0e93-4a18-834c-a49e1ed77407" providerId="ADAL" clId="{9C5BD01B-F20E-41A2-9B79-9146F06FE46D}" dt="2025-01-02T17:10:55.102" v="110" actId="165"/>
          <ac:grpSpMkLst>
            <pc:docMk/>
            <pc:sldMk cId="3697787146" sldId="301"/>
            <ac:grpSpMk id="4" creationId="{A4B708AA-C874-47A9-8402-1307FAF78E71}"/>
          </ac:grpSpMkLst>
        </pc:grpChg>
        <pc:grpChg chg="del mod">
          <ac:chgData name="Sara Weis" userId="6a51f4e6-0e93-4a18-834c-a49e1ed77407" providerId="ADAL" clId="{9C5BD01B-F20E-41A2-9B79-9146F06FE46D}" dt="2025-01-02T17:09:54.861" v="85" actId="478"/>
          <ac:grpSpMkLst>
            <pc:docMk/>
            <pc:sldMk cId="3697787146" sldId="301"/>
            <ac:grpSpMk id="7" creationId="{C4E3E8CA-09CF-4E30-B1BE-0C226D1D44BD}"/>
          </ac:grpSpMkLst>
        </pc:grpChg>
        <pc:grpChg chg="del mod">
          <ac:chgData name="Sara Weis" userId="6a51f4e6-0e93-4a18-834c-a49e1ed77407" providerId="ADAL" clId="{9C5BD01B-F20E-41A2-9B79-9146F06FE46D}" dt="2025-01-02T17:09:57.133" v="86" actId="478"/>
          <ac:grpSpMkLst>
            <pc:docMk/>
            <pc:sldMk cId="3697787146" sldId="301"/>
            <ac:grpSpMk id="63" creationId="{90812C86-76E7-434C-B059-E06486271081}"/>
          </ac:grpSpMkLst>
        </pc:grpChg>
        <pc:picChg chg="mod topLvl">
          <ac:chgData name="Sara Weis" userId="6a51f4e6-0e93-4a18-834c-a49e1ed77407" providerId="ADAL" clId="{9C5BD01B-F20E-41A2-9B79-9146F06FE46D}" dt="2025-01-02T17:12:04.497" v="250" actId="1076"/>
          <ac:picMkLst>
            <pc:docMk/>
            <pc:sldMk cId="3697787146" sldId="301"/>
            <ac:picMk id="42" creationId="{49B89DD3-5D40-463B-B3F1-9B32F3C36782}"/>
          </ac:picMkLst>
        </pc:picChg>
        <pc:picChg chg="mod topLvl">
          <ac:chgData name="Sara Weis" userId="6a51f4e6-0e93-4a18-834c-a49e1ed77407" providerId="ADAL" clId="{9C5BD01B-F20E-41A2-9B79-9146F06FE46D}" dt="2025-01-02T17:12:04.497" v="250" actId="1076"/>
          <ac:picMkLst>
            <pc:docMk/>
            <pc:sldMk cId="3697787146" sldId="301"/>
            <ac:picMk id="45" creationId="{E570AB55-64BA-4CA5-9FE3-C0D38EE395F6}"/>
          </ac:picMkLst>
        </pc:picChg>
      </pc:sldChg>
      <pc:sldChg chg="delSp modSp add">
        <pc:chgData name="Sara Weis" userId="6a51f4e6-0e93-4a18-834c-a49e1ed77407" providerId="ADAL" clId="{9C5BD01B-F20E-41A2-9B79-9146F06FE46D}" dt="2025-01-02T17:14:37.101" v="285" actId="403"/>
        <pc:sldMkLst>
          <pc:docMk/>
          <pc:sldMk cId="1103957350" sldId="302"/>
        </pc:sldMkLst>
        <pc:spChg chg="mod">
          <ac:chgData name="Sara Weis" userId="6a51f4e6-0e93-4a18-834c-a49e1ed77407" providerId="ADAL" clId="{9C5BD01B-F20E-41A2-9B79-9146F06FE46D}" dt="2025-01-02T17:14:37.101" v="285" actId="403"/>
          <ac:spMkLst>
            <pc:docMk/>
            <pc:sldMk cId="1103957350" sldId="302"/>
            <ac:spMk id="3" creationId="{5BA8A5DB-8B56-4375-B76B-1DD6A0A66638}"/>
          </ac:spMkLst>
        </pc:spChg>
        <pc:spChg chg="del">
          <ac:chgData name="Sara Weis" userId="6a51f4e6-0e93-4a18-834c-a49e1ed77407" providerId="ADAL" clId="{9C5BD01B-F20E-41A2-9B79-9146F06FE46D}" dt="2025-01-02T17:12:54.518" v="264" actId="478"/>
          <ac:spMkLst>
            <pc:docMk/>
            <pc:sldMk cId="1103957350" sldId="302"/>
            <ac:spMk id="40" creationId="{17A2B086-922E-4A22-B93C-C1506C9A891D}"/>
          </ac:spMkLst>
        </pc:spChg>
        <pc:spChg chg="del">
          <ac:chgData name="Sara Weis" userId="6a51f4e6-0e93-4a18-834c-a49e1ed77407" providerId="ADAL" clId="{9C5BD01B-F20E-41A2-9B79-9146F06FE46D}" dt="2025-01-02T17:12:57.167" v="265" actId="478"/>
          <ac:spMkLst>
            <pc:docMk/>
            <pc:sldMk cId="1103957350" sldId="302"/>
            <ac:spMk id="43" creationId="{1B63261F-5B34-4FAF-973A-117486502732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6" creationId="{5A252B7C-F590-4C54-827F-9FBE6CA430D2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7" creationId="{315EE578-6B8E-4185-AFF9-650CA9E307E7}"/>
          </ac:spMkLst>
        </pc:spChg>
        <pc:spChg chg="mod">
          <ac:chgData name="Sara Weis" userId="6a51f4e6-0e93-4a18-834c-a49e1ed77407" providerId="ADAL" clId="{9C5BD01B-F20E-41A2-9B79-9146F06FE46D}" dt="2025-01-02T17:13:10.166" v="274" actId="404"/>
          <ac:spMkLst>
            <pc:docMk/>
            <pc:sldMk cId="1103957350" sldId="302"/>
            <ac:spMk id="58" creationId="{22FA14AD-0F20-43B0-9C05-405C97092C1B}"/>
          </ac:spMkLst>
        </pc:spChg>
        <pc:spChg chg="mod">
          <ac:chgData name="Sara Weis" userId="6a51f4e6-0e93-4a18-834c-a49e1ed77407" providerId="ADAL" clId="{9C5BD01B-F20E-41A2-9B79-9146F06FE46D}" dt="2025-01-02T17:13:31.583" v="279" actId="552"/>
          <ac:spMkLst>
            <pc:docMk/>
            <pc:sldMk cId="1103957350" sldId="302"/>
            <ac:spMk id="61" creationId="{CF3FD69B-8EB1-432C-96B4-539FD5CDF51C}"/>
          </ac:spMkLst>
        </pc:spChg>
        <pc:spChg chg="mod">
          <ac:chgData name="Sara Weis" userId="6a51f4e6-0e93-4a18-834c-a49e1ed77407" providerId="ADAL" clId="{9C5BD01B-F20E-41A2-9B79-9146F06FE46D}" dt="2025-01-02T17:13:31.583" v="279" actId="552"/>
          <ac:spMkLst>
            <pc:docMk/>
            <pc:sldMk cId="1103957350" sldId="302"/>
            <ac:spMk id="96" creationId="{ED1F1807-7D76-42D5-A6C8-63B4164465BD}"/>
          </ac:spMkLst>
        </pc:spChg>
        <pc:grpChg chg="mod">
          <ac:chgData name="Sara Weis" userId="6a51f4e6-0e93-4a18-834c-a49e1ed77407" providerId="ADAL" clId="{9C5BD01B-F20E-41A2-9B79-9146F06FE46D}" dt="2025-01-02T17:13:22.434" v="277" actId="1076"/>
          <ac:grpSpMkLst>
            <pc:docMk/>
            <pc:sldMk cId="1103957350" sldId="302"/>
            <ac:grpSpMk id="2" creationId="{B3A65566-F496-49EC-9796-C4772607E706}"/>
          </ac:grpSpMkLst>
        </pc:grpChg>
        <pc:grpChg chg="mod">
          <ac:chgData name="Sara Weis" userId="6a51f4e6-0e93-4a18-834c-a49e1ed77407" providerId="ADAL" clId="{9C5BD01B-F20E-41A2-9B79-9146F06FE46D}" dt="2025-01-02T17:13:27.271" v="278" actId="1076"/>
          <ac:grpSpMkLst>
            <pc:docMk/>
            <pc:sldMk cId="1103957350" sldId="302"/>
            <ac:grpSpMk id="7" creationId="{C4E3E8CA-09CF-4E30-B1BE-0C226D1D44BD}"/>
          </ac:grpSpMkLst>
        </pc:grpChg>
        <pc:grpChg chg="mod">
          <ac:chgData name="Sara Weis" userId="6a51f4e6-0e93-4a18-834c-a49e1ed77407" providerId="ADAL" clId="{9C5BD01B-F20E-41A2-9B79-9146F06FE46D}" dt="2025-01-02T17:13:22.434" v="277" actId="1076"/>
          <ac:grpSpMkLst>
            <pc:docMk/>
            <pc:sldMk cId="1103957350" sldId="302"/>
            <ac:grpSpMk id="63" creationId="{90812C86-76E7-434C-B059-E06486271081}"/>
          </ac:grpSpMkLst>
        </pc:grpChg>
        <pc:picChg chg="del">
          <ac:chgData name="Sara Weis" userId="6a51f4e6-0e93-4a18-834c-a49e1ed77407" providerId="ADAL" clId="{9C5BD01B-F20E-41A2-9B79-9146F06FE46D}" dt="2025-01-02T17:12:54.518" v="264" actId="478"/>
          <ac:picMkLst>
            <pc:docMk/>
            <pc:sldMk cId="1103957350" sldId="302"/>
            <ac:picMk id="42" creationId="{49B89DD3-5D40-463B-B3F1-9B32F3C36782}"/>
          </ac:picMkLst>
        </pc:picChg>
        <pc:picChg chg="del">
          <ac:chgData name="Sara Weis" userId="6a51f4e6-0e93-4a18-834c-a49e1ed77407" providerId="ADAL" clId="{9C5BD01B-F20E-41A2-9B79-9146F06FE46D}" dt="2025-01-02T17:12:57.167" v="265" actId="478"/>
          <ac:picMkLst>
            <pc:docMk/>
            <pc:sldMk cId="1103957350" sldId="302"/>
            <ac:picMk id="45" creationId="{E570AB55-64BA-4CA5-9FE3-C0D38EE395F6}"/>
          </ac:picMkLst>
        </pc:picChg>
      </pc:sldChg>
      <pc:sldChg chg="del">
        <pc:chgData name="Sara Weis" userId="6a51f4e6-0e93-4a18-834c-a49e1ed77407" providerId="ADAL" clId="{9C5BD01B-F20E-41A2-9B79-9146F06FE46D}" dt="2025-01-02T16:47:45.042" v="1" actId="2696"/>
        <pc:sldMkLst>
          <pc:docMk/>
          <pc:sldMk cId="1407140874" sldId="309"/>
        </pc:sldMkLst>
      </pc:sldChg>
      <pc:sldChg chg="del">
        <pc:chgData name="Sara Weis" userId="6a51f4e6-0e93-4a18-834c-a49e1ed77407" providerId="ADAL" clId="{9C5BD01B-F20E-41A2-9B79-9146F06FE46D}" dt="2025-01-02T16:47:45.051" v="2" actId="2696"/>
        <pc:sldMkLst>
          <pc:docMk/>
          <pc:sldMk cId="2712744224" sldId="31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556F641-4CF0-450A-AF50-26BA00F47CDE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06F44C2-743C-4165-B45D-193A312A7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2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5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76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2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9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7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9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31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5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0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C4E3E8CA-09CF-4E30-B1BE-0C226D1D44BD}"/>
              </a:ext>
            </a:extLst>
          </p:cNvPr>
          <p:cNvGrpSpPr/>
          <p:nvPr/>
        </p:nvGrpSpPr>
        <p:grpSpPr>
          <a:xfrm rot="10800000">
            <a:off x="339932" y="1788062"/>
            <a:ext cx="3995095" cy="2197149"/>
            <a:chOff x="163709" y="1233943"/>
            <a:chExt cx="3184887" cy="1751566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A252B7C-F590-4C54-827F-9FBE6CA430D2}"/>
                </a:ext>
              </a:extLst>
            </p:cNvPr>
            <p:cNvSpPr txBox="1"/>
            <p:nvPr/>
          </p:nvSpPr>
          <p:spPr>
            <a:xfrm rot="10800000">
              <a:off x="2853216" y="2034625"/>
              <a:ext cx="441136" cy="245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15EE578-6B8E-4185-AFF9-650CA9E307E7}"/>
                </a:ext>
              </a:extLst>
            </p:cNvPr>
            <p:cNvSpPr txBox="1"/>
            <p:nvPr/>
          </p:nvSpPr>
          <p:spPr>
            <a:xfrm rot="10800000">
              <a:off x="2884398" y="2535385"/>
              <a:ext cx="337624" cy="245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N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2FA14AD-0F20-43B0-9C05-405C97092C1B}"/>
                </a:ext>
              </a:extLst>
            </p:cNvPr>
            <p:cNvSpPr txBox="1"/>
            <p:nvPr/>
          </p:nvSpPr>
          <p:spPr>
            <a:xfrm rot="10800000">
              <a:off x="2797560" y="1478930"/>
              <a:ext cx="551036" cy="245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0EFE1BD5-A454-4E5B-8809-834A522D21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0800000">
              <a:off x="163709" y="1260235"/>
              <a:ext cx="2633851" cy="1725274"/>
            </a:xfrm>
            <a:prstGeom prst="rect">
              <a:avLst/>
            </a:prstGeom>
          </p:spPr>
        </p:pic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241A5BF4-DD8F-4DF1-BF3D-18951A7E458A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178684" y="1233943"/>
              <a:ext cx="35661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CF3FD69B-8EB1-432C-96B4-539FD5CDF51C}"/>
              </a:ext>
            </a:extLst>
          </p:cNvPr>
          <p:cNvSpPr txBox="1"/>
          <p:nvPr/>
        </p:nvSpPr>
        <p:spPr>
          <a:xfrm>
            <a:off x="84052" y="16468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90812C86-76E7-434C-B059-E06486271081}"/>
              </a:ext>
            </a:extLst>
          </p:cNvPr>
          <p:cNvGrpSpPr/>
          <p:nvPr/>
        </p:nvGrpSpPr>
        <p:grpSpPr>
          <a:xfrm>
            <a:off x="210691" y="4278165"/>
            <a:ext cx="2000782" cy="2288249"/>
            <a:chOff x="3609706" y="4045004"/>
            <a:chExt cx="1586652" cy="1814619"/>
          </a:xfrm>
        </p:grpSpPr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514A57D4-8488-4C6E-83C2-C6286FBF6BBB}"/>
                </a:ext>
              </a:extLst>
            </p:cNvPr>
            <p:cNvGrpSpPr/>
            <p:nvPr/>
          </p:nvGrpSpPr>
          <p:grpSpPr>
            <a:xfrm>
              <a:off x="3609706" y="4045004"/>
              <a:ext cx="1185587" cy="1814619"/>
              <a:chOff x="8057314" y="1584143"/>
              <a:chExt cx="1185587" cy="1814619"/>
            </a:xfrm>
          </p:grpSpPr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1A8046CC-EB0E-4880-B777-74C54D58C4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r="3458"/>
              <a:stretch/>
            </p:blipFill>
            <p:spPr>
              <a:xfrm>
                <a:off x="8573886" y="3150363"/>
                <a:ext cx="622782" cy="248399"/>
              </a:xfrm>
              <a:prstGeom prst="rect">
                <a:avLst/>
              </a:prstGeom>
            </p:spPr>
          </p:pic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DAA022CF-1341-4A4E-ACF9-0C0DF31D70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578229" y="2874255"/>
                <a:ext cx="623718" cy="222119"/>
              </a:xfrm>
              <a:prstGeom prst="rect">
                <a:avLst/>
              </a:prstGeom>
            </p:spPr>
          </p:pic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A5E10A34-C9EC-4B13-AD8B-68D131BF329F}"/>
                  </a:ext>
                </a:extLst>
              </p:cNvPr>
              <p:cNvSpPr txBox="1"/>
              <p:nvPr/>
            </p:nvSpPr>
            <p:spPr>
              <a:xfrm>
                <a:off x="8073783" y="3149197"/>
                <a:ext cx="526534" cy="201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7A2049D8-559C-4A08-9B61-13FBA69105AF}"/>
                  </a:ext>
                </a:extLst>
              </p:cNvPr>
              <p:cNvSpPr txBox="1"/>
              <p:nvPr/>
            </p:nvSpPr>
            <p:spPr>
              <a:xfrm>
                <a:off x="8057314" y="2893218"/>
                <a:ext cx="557043" cy="2013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OL1A1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ECBFCCA-2D6D-4555-A4C3-BBFA35773546}"/>
                  </a:ext>
                </a:extLst>
              </p:cNvPr>
              <p:cNvSpPr txBox="1"/>
              <p:nvPr/>
            </p:nvSpPr>
            <p:spPr>
              <a:xfrm rot="16200000">
                <a:off x="8164645" y="2268331"/>
                <a:ext cx="1054085" cy="201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err="1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-CTRL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6E213D06-6116-46F6-B91C-936EA2FF7EB5}"/>
                  </a:ext>
                </a:extLst>
              </p:cNvPr>
              <p:cNvSpPr txBox="1"/>
              <p:nvPr/>
            </p:nvSpPr>
            <p:spPr>
              <a:xfrm rot="16200000">
                <a:off x="8239130" y="2139418"/>
                <a:ext cx="1311910" cy="201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i-COL1A1 (10 </a:t>
                </a:r>
                <a:r>
                  <a:rPr lang="en-US" sz="105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A40695FA-B494-49CF-8D5A-EDE7CFDB35CC}"/>
                  </a:ext>
                </a:extLst>
              </p:cNvPr>
              <p:cNvSpPr txBox="1"/>
              <p:nvPr/>
            </p:nvSpPr>
            <p:spPr>
              <a:xfrm rot="16200000">
                <a:off x="8431854" y="2142445"/>
                <a:ext cx="1305856" cy="201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i-COL1A1 (50 </a:t>
                </a:r>
                <a:r>
                  <a:rPr lang="en-US" sz="105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52F33098-0230-4453-A2C1-C386AB9A5DE4}"/>
                  </a:ext>
                </a:extLst>
              </p:cNvPr>
              <p:cNvSpPr txBox="1"/>
              <p:nvPr/>
            </p:nvSpPr>
            <p:spPr>
              <a:xfrm>
                <a:off x="8585433" y="1657762"/>
                <a:ext cx="657468" cy="207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CAF-1299</a:t>
                </a:r>
              </a:p>
            </p:txBody>
          </p: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30F2A25-C97F-4F71-AF17-8D47867727D6}"/>
                </a:ext>
              </a:extLst>
            </p:cNvPr>
            <p:cNvSpPr txBox="1"/>
            <p:nvPr/>
          </p:nvSpPr>
          <p:spPr>
            <a:xfrm>
              <a:off x="4739740" y="5339095"/>
              <a:ext cx="456618" cy="201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50Kd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C256C885-9A2B-4C79-948C-6E2281B96EE6}"/>
                </a:ext>
              </a:extLst>
            </p:cNvPr>
            <p:cNvCxnSpPr/>
            <p:nvPr/>
          </p:nvCxnSpPr>
          <p:spPr>
            <a:xfrm>
              <a:off x="4748430" y="5531161"/>
              <a:ext cx="182880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049B431-FF8E-407D-AE9D-3367E621DF82}"/>
                </a:ext>
              </a:extLst>
            </p:cNvPr>
            <p:cNvSpPr txBox="1"/>
            <p:nvPr/>
          </p:nvSpPr>
          <p:spPr>
            <a:xfrm>
              <a:off x="4754339" y="5658263"/>
              <a:ext cx="396871" cy="201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7Kd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5CCA0806-0142-4D2B-9922-6BBC4F44C565}"/>
                </a:ext>
              </a:extLst>
            </p:cNvPr>
            <p:cNvCxnSpPr/>
            <p:nvPr/>
          </p:nvCxnSpPr>
          <p:spPr>
            <a:xfrm>
              <a:off x="4736636" y="5671046"/>
              <a:ext cx="182880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ED1F1807-7D76-42D5-A6C8-63B4164465BD}"/>
              </a:ext>
            </a:extLst>
          </p:cNvPr>
          <p:cNvSpPr txBox="1"/>
          <p:nvPr/>
        </p:nvSpPr>
        <p:spPr>
          <a:xfrm>
            <a:off x="84052" y="42484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3A65566-F496-49EC-9796-C4772607E706}"/>
              </a:ext>
            </a:extLst>
          </p:cNvPr>
          <p:cNvGrpSpPr/>
          <p:nvPr/>
        </p:nvGrpSpPr>
        <p:grpSpPr>
          <a:xfrm>
            <a:off x="2307041" y="4604386"/>
            <a:ext cx="4481602" cy="2006862"/>
            <a:chOff x="158519" y="3218327"/>
            <a:chExt cx="6536238" cy="2926930"/>
          </a:xfrm>
        </p:grpSpPr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8ED21E5B-ED80-49C3-935D-1DDCBA893373}"/>
                </a:ext>
              </a:extLst>
            </p:cNvPr>
            <p:cNvGrpSpPr/>
            <p:nvPr/>
          </p:nvGrpSpPr>
          <p:grpSpPr>
            <a:xfrm>
              <a:off x="158519" y="3218327"/>
              <a:ext cx="6536238" cy="2910904"/>
              <a:chOff x="236325" y="7242365"/>
              <a:chExt cx="4298105" cy="1914152"/>
            </a:xfrm>
          </p:grpSpPr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7CB1EFD9-A0E1-4A97-9025-B4BAB646FFAB}"/>
                  </a:ext>
                </a:extLst>
              </p:cNvPr>
              <p:cNvGrpSpPr/>
              <p:nvPr/>
            </p:nvGrpSpPr>
            <p:grpSpPr>
              <a:xfrm>
                <a:off x="236325" y="7242366"/>
                <a:ext cx="4208094" cy="1622434"/>
                <a:chOff x="2890276" y="1280407"/>
                <a:chExt cx="6414127" cy="2513406"/>
              </a:xfrm>
            </p:grpSpPr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52AA5F1A-EE51-4C0F-BBDB-742FF1A3600E}"/>
                    </a:ext>
                  </a:extLst>
                </p:cNvPr>
                <p:cNvGrpSpPr/>
                <p:nvPr/>
              </p:nvGrpSpPr>
              <p:grpSpPr>
                <a:xfrm>
                  <a:off x="2890276" y="1638896"/>
                  <a:ext cx="6404560" cy="2154917"/>
                  <a:chOff x="2872691" y="618989"/>
                  <a:chExt cx="6404560" cy="2154917"/>
                </a:xfrm>
              </p:grpSpPr>
              <p:pic>
                <p:nvPicPr>
                  <p:cNvPr id="94" name="Picture 93">
                    <a:extLst>
                      <a:ext uri="{FF2B5EF4-FFF2-40B4-BE49-F238E27FC236}">
                        <a16:creationId xmlns:a16="http://schemas.microsoft.com/office/drawing/2014/main" id="{B3058717-DA8E-49A7-A4B4-C54B8E1B5FB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74989"/>
                  <a:stretch/>
                </p:blipFill>
                <p:spPr>
                  <a:xfrm>
                    <a:off x="2872691" y="618989"/>
                    <a:ext cx="2098216" cy="2144503"/>
                  </a:xfrm>
                  <a:prstGeom prst="rect">
                    <a:avLst/>
                  </a:prstGeom>
                </p:spPr>
              </p:pic>
              <p:pic>
                <p:nvPicPr>
                  <p:cNvPr id="95" name="Picture 94">
                    <a:extLst>
                      <a:ext uri="{FF2B5EF4-FFF2-40B4-BE49-F238E27FC236}">
                        <a16:creationId xmlns:a16="http://schemas.microsoft.com/office/drawing/2014/main" id="{2B1B5999-F249-4292-B3E2-AB7E36725EA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75005"/>
                  <a:stretch/>
                </p:blipFill>
                <p:spPr>
                  <a:xfrm>
                    <a:off x="7183018" y="623063"/>
                    <a:ext cx="2094233" cy="2150843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FDFBCCBB-8C16-435A-889C-9899E7AC27F6}"/>
                    </a:ext>
                  </a:extLst>
                </p:cNvPr>
                <p:cNvSpPr txBox="1"/>
                <p:nvPr/>
              </p:nvSpPr>
              <p:spPr>
                <a:xfrm>
                  <a:off x="3407109" y="1280410"/>
                  <a:ext cx="994033" cy="3772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5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</a:t>
                  </a:r>
                  <a:r>
                    <a:rPr lang="en-US" sz="1050">
                      <a:latin typeface="Arial" panose="020B0604020202020204" pitchFamily="34" charset="0"/>
                      <a:cs typeface="Arial" panose="020B0604020202020204" pitchFamily="34" charset="0"/>
                    </a:rPr>
                    <a:t>-CTRL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B8A5F804-AB75-4BB2-8D8C-2D6962AB8992}"/>
                    </a:ext>
                  </a:extLst>
                </p:cNvPr>
                <p:cNvSpPr txBox="1"/>
                <p:nvPr/>
              </p:nvSpPr>
              <p:spPr>
                <a:xfrm>
                  <a:off x="7335551" y="1280407"/>
                  <a:ext cx="1968852" cy="37725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50">
                      <a:latin typeface="Arial" panose="020B0604020202020204" pitchFamily="34" charset="0"/>
                      <a:cs typeface="Arial" panose="020B0604020202020204" pitchFamily="34" charset="0"/>
                    </a:rPr>
                    <a:t>si-COL1A1 (50 </a:t>
                  </a:r>
                  <a:r>
                    <a:rPr lang="en-US" sz="105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M</a:t>
                  </a:r>
                  <a:r>
                    <a:rPr lang="en-US" sz="105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pic>
            <p:nvPicPr>
              <p:cNvPr id="86" name="Picture 85">
                <a:extLst>
                  <a:ext uri="{FF2B5EF4-FFF2-40B4-BE49-F238E27FC236}">
                    <a16:creationId xmlns:a16="http://schemas.microsoft.com/office/drawing/2014/main" id="{B4613E11-2EC8-4061-85E1-BBD8098F8F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74900"/>
              <a:stretch/>
            </p:blipFill>
            <p:spPr>
              <a:xfrm>
                <a:off x="1651819" y="7469684"/>
                <a:ext cx="1376569" cy="1396730"/>
              </a:xfrm>
              <a:prstGeom prst="rect">
                <a:avLst/>
              </a:prstGeom>
            </p:spPr>
          </p:pic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F7A5E6A7-A1F0-4E88-8F54-240DE96E08BD}"/>
                  </a:ext>
                </a:extLst>
              </p:cNvPr>
              <p:cNvSpPr txBox="1"/>
              <p:nvPr/>
            </p:nvSpPr>
            <p:spPr>
              <a:xfrm>
                <a:off x="1612895" y="7242365"/>
                <a:ext cx="1697832" cy="243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i-COL1A1 (10 </a:t>
                </a:r>
                <a:r>
                  <a:rPr lang="en-US" sz="105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FF703AE6-B513-49E9-842C-7517524F53A4}"/>
                  </a:ext>
                </a:extLst>
              </p:cNvPr>
              <p:cNvSpPr txBox="1"/>
              <p:nvPr/>
            </p:nvSpPr>
            <p:spPr>
              <a:xfrm flipH="1">
                <a:off x="3642572" y="8879518"/>
                <a:ext cx="8918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N </a:t>
                </a:r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1200" b="1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b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1200" b="1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ECCE8FB-53ED-46B1-85B6-2DC1393C6D65}"/>
                </a:ext>
              </a:extLst>
            </p:cNvPr>
            <p:cNvCxnSpPr/>
            <p:nvPr/>
          </p:nvCxnSpPr>
          <p:spPr>
            <a:xfrm>
              <a:off x="228122" y="5846843"/>
              <a:ext cx="31488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CA2CBE0-8A1E-459A-84CF-734548C7AB8E}"/>
                </a:ext>
              </a:extLst>
            </p:cNvPr>
            <p:cNvSpPr txBox="1"/>
            <p:nvPr/>
          </p:nvSpPr>
          <p:spPr>
            <a:xfrm>
              <a:off x="243883" y="5891340"/>
              <a:ext cx="598241" cy="2539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5BA8A5DB-8B56-4375-B76B-1DD6A0A66638}"/>
              </a:ext>
            </a:extLst>
          </p:cNvPr>
          <p:cNvSpPr/>
          <p:nvPr/>
        </p:nvSpPr>
        <p:spPr>
          <a:xfrm>
            <a:off x="84052" y="125476"/>
            <a:ext cx="6580989" cy="1242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:  FN and COL co-patterning requires FN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 Enlargement highlights FN-COL co-patterning: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ce staining shows FN and COL content produced by CAF-1299 seeded at low density.  Images are representative of at least 3 independent experiments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:  COL1A1 knockdown does not alter FN assembly: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F-1299 were treated with siRNA for a scramble control vs. COL1A1.  After 72 hours, immunofluorescence staining shows FN content.  Images are representative of at least 3 independent experiments.  Blot confirms COL1A1 knockdown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3957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543e7ec-7072-4b75-829f-0ed03e19ff1e">
      <Terms xmlns="http://schemas.microsoft.com/office/infopath/2007/PartnerControls"/>
    </lcf76f155ced4ddcb4097134ff3c332f>
    <TaxCatchAll xmlns="57a0c4cc-3c09-49e8-920e-d8be8823b2ff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F3B51C6BCD074793790340586B5297" ma:contentTypeVersion="18" ma:contentTypeDescription="Create a new document." ma:contentTypeScope="" ma:versionID="d8e7e0b6111b9d67775a07373b940835">
  <xsd:schema xmlns:xsd="http://www.w3.org/2001/XMLSchema" xmlns:xs="http://www.w3.org/2001/XMLSchema" xmlns:p="http://schemas.microsoft.com/office/2006/metadata/properties" xmlns:ns2="57a0c4cc-3c09-49e8-920e-d8be8823b2ff" xmlns:ns3="2543e7ec-7072-4b75-829f-0ed03e19ff1e" targetNamespace="http://schemas.microsoft.com/office/2006/metadata/properties" ma:root="true" ma:fieldsID="26eab72f2527c02910f532a8625ffb45" ns2:_="" ns3:_="">
    <xsd:import namespace="57a0c4cc-3c09-49e8-920e-d8be8823b2ff"/>
    <xsd:import namespace="2543e7ec-7072-4b75-829f-0ed03e19ff1e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a0c4cc-3c09-49e8-920e-d8be8823b2f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fe539f8-3b21-43ac-9575-bd53185d5a89}" ma:internalName="TaxCatchAll" ma:showField="CatchAllData" ma:web="57a0c4cc-3c09-49e8-920e-d8be8823b2f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43e7ec-7072-4b75-829f-0ed03e19ff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2ccd466c-82b6-42a3-8ba5-5c7db83406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28AF018-5240-4F2F-B0A7-10A84DD9D2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8778B21-93DC-4DE6-9C7D-29A88DF3DBC8}">
  <ds:schemaRefs>
    <ds:schemaRef ds:uri="57a0c4cc-3c09-49e8-920e-d8be8823b2ff"/>
    <ds:schemaRef ds:uri="http://purl.org/dc/elements/1.1/"/>
    <ds:schemaRef ds:uri="http://schemas.microsoft.com/office/2006/metadata/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2543e7ec-7072-4b75-829f-0ed03e19ff1e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1E279D-CEC9-47C5-B8DD-CF8E61B016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7a0c4cc-3c09-49e8-920e-d8be8823b2ff"/>
    <ds:schemaRef ds:uri="2543e7ec-7072-4b75-829f-0ed03e19ff1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7</TotalTime>
  <Words>126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Chengsheng</dc:creator>
  <cp:lastModifiedBy>Weis, Sara</cp:lastModifiedBy>
  <cp:revision>20</cp:revision>
  <dcterms:created xsi:type="dcterms:W3CDTF">2024-03-19T17:07:22Z</dcterms:created>
  <dcterms:modified xsi:type="dcterms:W3CDTF">2025-01-02T17:22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F3B51C6BCD074793790340586B5297</vt:lpwstr>
  </property>
  <property fmtid="{D5CDD505-2E9C-101B-9397-08002B2CF9AE}" pid="3" name="MediaServiceImageTags">
    <vt:lpwstr/>
  </property>
</Properties>
</file>